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1795548"/>
              </p:ext>
            </p:extLst>
          </p:nvPr>
        </p:nvGraphicFramePr>
        <p:xfrm>
          <a:off x="905256" y="1782108"/>
          <a:ext cx="7504853" cy="2021286"/>
        </p:xfrm>
        <a:graphic>
          <a:graphicData uri="http://schemas.openxmlformats.org/drawingml/2006/table">
            <a:tbl>
              <a:tblPr/>
              <a:tblGrid>
                <a:gridCol w="1084233"/>
                <a:gridCol w="790287"/>
                <a:gridCol w="704088"/>
                <a:gridCol w="830694"/>
                <a:gridCol w="847775"/>
                <a:gridCol w="809414"/>
                <a:gridCol w="802921"/>
                <a:gridCol w="801553"/>
                <a:gridCol w="833888"/>
              </a:tblGrid>
              <a:tr h="31186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D3 cerebellum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5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6 S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LBD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028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in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lum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uregen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henol / Chlorofor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ure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henol / Chlorofor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ure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henol / Chlorofor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ure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read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966910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41255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373346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208563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46300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67798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595795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979911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nique hg19 aligned read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00965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430585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911827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92299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897039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1962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65242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2657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clear genome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er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3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r18/chr19 coverage ratio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05256" y="4294162"/>
            <a:ext cx="6861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/>
              <a:t>Table S7. </a:t>
            </a:r>
            <a:r>
              <a:rPr lang="en-US" sz="1200" b="1" dirty="0" smtClean="0"/>
              <a:t>WGS summary results of samples isolated with different methods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215672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6</TotalTime>
  <Words>80</Words>
  <Application>Microsoft Macintosh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53:29Z</dcterms:modified>
</cp:coreProperties>
</file>